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3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notesSlides/notesSlide4.xml" ContentType="application/vnd.openxmlformats-officedocument.presentationml.notesSl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711" r:id="rId2"/>
    <p:sldId id="707" r:id="rId3"/>
    <p:sldId id="257" r:id="rId4"/>
    <p:sldId id="713" r:id="rId5"/>
    <p:sldId id="688" r:id="rId6"/>
    <p:sldId id="689" r:id="rId7"/>
    <p:sldId id="690" r:id="rId8"/>
    <p:sldId id="698" r:id="rId9"/>
    <p:sldId id="704" r:id="rId10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458" autoAdjust="0"/>
    <p:restoredTop sz="96233" autoAdjust="0"/>
  </p:normalViewPr>
  <p:slideViewPr>
    <p:cSldViewPr snapToGrid="0">
      <p:cViewPr varScale="1">
        <p:scale>
          <a:sx n="79" d="100"/>
          <a:sy n="79" d="100"/>
        </p:scale>
        <p:origin x="782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01_&#23398;&#20301;&#22522;&#30990;&#35542;&#25991;\20220912CH&#22793;&#30064;&#25968;&#12398;&#34920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01_&#23398;&#20301;&#22522;&#30990;&#35542;&#25991;\01.Submit&#29992;\ddPCR&#12394;&#12375;20220913Fesibility%20oncoplo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172.16.26.80\kwatanabe\03_Manuscript\03_&#23398;&#20301;&#22522;&#30990;&#35542;&#25991;\20220801&#35542;&#25991;&#12487;&#12540;&#12479;&#33205;&#30284;%20&#33131;&#30221;&#12398;&#33256;&#24202;&#24773;&#22577;&#12395;&#12424;&#12427;&#35413;&#20385;&#12487;&#12540;&#12479;ver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172.16.26.80\kwatanabe\03_Manuscript\03_&#23398;&#20301;&#22522;&#30990;&#35542;&#25991;\20220801&#35542;&#25991;&#12487;&#12540;&#12479;&#33205;&#30284;%20&#33131;&#30221;&#12398;&#33256;&#24202;&#24773;&#22577;&#12395;&#12424;&#12427;&#35413;&#20385;&#12487;&#12540;&#12479;ver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172.16.26.80\kwatanabe\03_Manuscript\03_&#23398;&#20301;&#22522;&#30990;&#35542;&#25991;\20220801&#35542;&#25991;&#12487;&#12540;&#12479;&#33205;&#30284;%20&#33131;&#30221;&#12398;&#33256;&#24202;&#24773;&#22577;&#12395;&#12424;&#12427;&#35413;&#20385;&#12487;&#12540;&#12479;ver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172.16.26.80\kwatanabe\03_Manuscript\03_&#23398;&#20301;&#22522;&#30990;&#35542;&#25991;\20220801&#35542;&#25991;&#12487;&#12540;&#12479;&#33205;&#30284;%20&#33131;&#30221;&#12398;&#33256;&#24202;&#24773;&#22577;&#12395;&#12424;&#12427;&#35413;&#20385;&#12487;&#12540;&#12479;ver2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172.16.26.80\kwatanabe\03_Manuscript\03_&#23398;&#20301;&#22522;&#30990;&#35542;&#25991;\20220801&#35542;&#25991;&#12487;&#12540;&#12479;&#33205;&#30284;%20&#33131;&#30221;&#12398;&#33256;&#24202;&#24773;&#22577;&#12395;&#12424;&#12427;&#35413;&#20385;&#12487;&#12540;&#12479;ver2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083230586234717"/>
          <c:y val="0.23369315401610297"/>
          <c:w val="0.49005038413280361"/>
          <c:h val="0.75944495592780759"/>
        </c:manualLayout>
      </c:layout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6D3-4E0A-80C5-86136E56991B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6D3-4E0A-80C5-86136E56991B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6D3-4E0A-80C5-86136E56991B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6D3-4E0A-80C5-86136E56991B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76D3-4E0A-80C5-86136E56991B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76D3-4E0A-80C5-86136E56991B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76D3-4E0A-80C5-86136E56991B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76D3-4E0A-80C5-86136E56991B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76D3-4E0A-80C5-86136E56991B}"/>
              </c:ext>
            </c:extLst>
          </c:dPt>
          <c:dLbls>
            <c:dLbl>
              <c:idx val="0"/>
              <c:layout>
                <c:manualLayout>
                  <c:x val="-0.16305248427559102"/>
                  <c:y val="-0.23623538786868847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lang="ja-JP" sz="1000" b="1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defRPr>
                    </a:pPr>
                    <a:fld id="{78E43937-8C45-450A-9B6F-5F9C50687788}" type="CATEGORYNAME">
                      <a:rPr lang="en-US" altLang="ja-JP" sz="1000" b="1" i="1"/>
                      <a:pPr>
                        <a:defRPr lang="ja-JP" sz="1000" b="1"/>
                      </a:pPr>
                      <a:t>[CATEGORY NAME]</a:t>
                    </a:fld>
                    <a:r>
                      <a:rPr lang="en-US" sz="1000" b="1" dirty="0"/>
                      <a:t>
</a:t>
                    </a:r>
                    <a:fld id="{6395D780-907C-4CCA-9C4A-603D0E980584}" type="PERCENTAGE">
                      <a:rPr lang="en-US" altLang="ja-JP" sz="1000" b="1"/>
                      <a:pPr>
                        <a:defRPr lang="ja-JP" sz="1000" b="1"/>
                      </a:pPr>
                      <a:t>[PERCENTAGE]</a:t>
                    </a:fld>
                    <a:r>
                      <a:rPr lang="en-US" sz="1000" b="1" dirty="0"/>
                      <a:t>(22/33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000" b="1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Calibri" panose="020F0502020204030204" pitchFamily="34" charset="0"/>
                      <a:ea typeface="+mn-ea"/>
                      <a:cs typeface="Calibri" panose="020F0502020204030204" pitchFamily="34" charset="0"/>
                    </a:defRPr>
                  </a:pPr>
                  <a:endParaRPr lang="en-US"/>
                </a:p>
              </c:txPr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76D3-4E0A-80C5-86136E56991B}"/>
                </c:ext>
              </c:extLst>
            </c:dLbl>
            <c:dLbl>
              <c:idx val="1"/>
              <c:layout>
                <c:manualLayout>
                  <c:x val="1.2230332625950878E-2"/>
                  <c:y val="4.4375224382985697E-2"/>
                </c:manualLayout>
              </c:layout>
              <c:tx>
                <c:rich>
                  <a:bodyPr/>
                  <a:lstStyle/>
                  <a:p>
                    <a:fld id="{8D865B46-9E3D-4853-9060-3C16135A1B10}" type="CATEGORYNAME">
                      <a:rPr lang="en-US" altLang="ja-JP" i="1"/>
                      <a:pPr/>
                      <a:t>[CATEGORY NAME]</a:t>
                    </a:fld>
                    <a:r>
                      <a:rPr lang="en-US" altLang="ja-JP" baseline="0" dirty="0"/>
                      <a:t>
</a:t>
                    </a:r>
                    <a:fld id="{73FA4557-D26A-47EA-8401-4614E1C858C2}" type="PERCENTAGE">
                      <a:rPr lang="en-US" altLang="ja-JP" baseline="0"/>
                      <a:pPr/>
                      <a:t>[PERCENTAGE]</a:t>
                    </a:fld>
                    <a:r>
                      <a:rPr lang="en-US" altLang="ja-JP" baseline="0" dirty="0"/>
                      <a:t>(</a:t>
                    </a:r>
                    <a:r>
                      <a:rPr lang="en-US" altLang="ja-JP" sz="1000" b="0" i="0" u="none" strike="noStrike" kern="1200" baseline="0" dirty="0">
                        <a:solidFill>
                          <a:sysClr val="windowText" lastClr="000000">
                            <a:lumMod val="75000"/>
                            <a:lumOff val="25000"/>
                          </a:sysClr>
                        </a:solidFill>
                      </a:rPr>
                      <a:t>3/33</a:t>
                    </a:r>
                    <a:r>
                      <a:rPr lang="en-US" altLang="ja-JP" baseline="0" dirty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76D3-4E0A-80C5-86136E56991B}"/>
                </c:ext>
              </c:extLst>
            </c:dLbl>
            <c:dLbl>
              <c:idx val="2"/>
              <c:layout>
                <c:manualLayout>
                  <c:x val="9.5930906081430161E-4"/>
                  <c:y val="9.6475241607298132E-2"/>
                </c:manualLayout>
              </c:layout>
              <c:tx>
                <c:rich>
                  <a:bodyPr/>
                  <a:lstStyle/>
                  <a:p>
                    <a:fld id="{398112C6-CE64-455C-9EAF-E66313FCB30F}" type="CATEGORYNAME">
                      <a:rPr lang="en-US" altLang="ja-JP" i="1"/>
                      <a:pPr/>
                      <a:t>[CATEGORY NAME]</a:t>
                    </a:fld>
                    <a:r>
                      <a:rPr lang="en-US" altLang="ja-JP" baseline="0" dirty="0"/>
                      <a:t>
</a:t>
                    </a:r>
                    <a:fld id="{0CD51B1C-967F-4B40-AA13-8FDAFF69A867}" type="PERCENTAGE">
                      <a:rPr lang="en-US" altLang="ja-JP" baseline="0"/>
                      <a:pPr/>
                      <a:t>[PERCENTAGE]</a:t>
                    </a:fld>
                    <a:r>
                      <a:rPr lang="en-US" altLang="ja-JP" baseline="0" dirty="0"/>
                      <a:t>(</a:t>
                    </a:r>
                    <a:r>
                      <a:rPr lang="en-US" altLang="ja-JP" sz="1000" b="0" i="0" u="none" strike="noStrike" kern="1200" baseline="0" dirty="0">
                        <a:solidFill>
                          <a:sysClr val="windowText" lastClr="000000">
                            <a:lumMod val="75000"/>
                            <a:lumOff val="25000"/>
                          </a:sysClr>
                        </a:solidFill>
                      </a:rPr>
                      <a:t>2/33</a:t>
                    </a:r>
                    <a:r>
                      <a:rPr lang="en-US" altLang="ja-JP" baseline="0" dirty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76D3-4E0A-80C5-86136E56991B}"/>
                </c:ext>
              </c:extLst>
            </c:dLbl>
            <c:dLbl>
              <c:idx val="3"/>
              <c:layout>
                <c:manualLayout>
                  <c:x val="-3.672744381232048E-2"/>
                  <c:y val="6.6042164286737065E-2"/>
                </c:manualLayout>
              </c:layout>
              <c:tx>
                <c:rich>
                  <a:bodyPr/>
                  <a:lstStyle/>
                  <a:p>
                    <a:fld id="{C3F029CD-378A-4722-98BE-22209FFF449E}" type="CATEGORYNAME">
                      <a:rPr lang="en-US" altLang="ja-JP" i="1"/>
                      <a:pPr/>
                      <a:t>[CATEGORY NAME]</a:t>
                    </a:fld>
                    <a:r>
                      <a:rPr lang="en-US" altLang="ja-JP" baseline="0" dirty="0"/>
                      <a:t>
1/33(</a:t>
                    </a:r>
                    <a:fld id="{8CE8DF65-AC94-49AC-9254-15429F9ABD55}" type="PERCENTAGE">
                      <a:rPr lang="en-US" altLang="ja-JP" baseline="0"/>
                      <a:pPr/>
                      <a:t>[PERCENTAGE]</a:t>
                    </a:fld>
                    <a:r>
                      <a:rPr lang="en-US" altLang="ja-JP" baseline="0" dirty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76D3-4E0A-80C5-86136E56991B}"/>
                </c:ext>
              </c:extLst>
            </c:dLbl>
            <c:dLbl>
              <c:idx val="4"/>
              <c:layout>
                <c:manualLayout>
                  <c:x val="-4.6414134206710457E-2"/>
                  <c:y val="2.4993929986282807E-2"/>
                </c:manualLayout>
              </c:layout>
              <c:tx>
                <c:rich>
                  <a:bodyPr/>
                  <a:lstStyle/>
                  <a:p>
                    <a:fld id="{B77EE9BA-66F2-4D45-BC8D-E4C1A836D472}" type="CATEGORYNAME">
                      <a:rPr lang="en-US" altLang="ja-JP" i="1"/>
                      <a:pPr/>
                      <a:t>[CATEGORY NAME]</a:t>
                    </a:fld>
                    <a:r>
                      <a:rPr lang="en-US" altLang="ja-JP" baseline="0"/>
                      <a:t>
1/33(</a:t>
                    </a:r>
                    <a:fld id="{00D0B9BE-373A-4E8B-B322-0822C24A0640}" type="PERCENTAGE">
                      <a:rPr lang="en-US" altLang="ja-JP" baseline="0"/>
                      <a:pPr/>
                      <a:t>[PERCENTAGE]</a:t>
                    </a:fld>
                    <a:r>
                      <a:rPr lang="en-US" altLang="ja-JP" baseline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76D3-4E0A-80C5-86136E56991B}"/>
                </c:ext>
              </c:extLst>
            </c:dLbl>
            <c:dLbl>
              <c:idx val="5"/>
              <c:layout>
                <c:manualLayout>
                  <c:x val="-6.1187990733266168E-2"/>
                  <c:y val="-3.6964204558424661E-2"/>
                </c:manualLayout>
              </c:layout>
              <c:tx>
                <c:rich>
                  <a:bodyPr/>
                  <a:lstStyle/>
                  <a:p>
                    <a:fld id="{AA406A59-A9D0-4628-ADD7-0C780F0A5804}" type="CATEGORYNAME">
                      <a:rPr lang="en-US" altLang="ja-JP" i="1"/>
                      <a:pPr/>
                      <a:t>[CATEGORY NAME]</a:t>
                    </a:fld>
                    <a:r>
                      <a:rPr lang="en-US" altLang="ja-JP" baseline="0"/>
                      <a:t>
1/33(</a:t>
                    </a:r>
                    <a:fld id="{647FF7F2-048F-4B9C-9335-1279E81D924D}" type="PERCENTAGE">
                      <a:rPr lang="en-US" altLang="ja-JP" baseline="0"/>
                      <a:pPr/>
                      <a:t>[PERCENTAGE]</a:t>
                    </a:fld>
                    <a:r>
                      <a:rPr lang="en-US" altLang="ja-JP" baseline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76D3-4E0A-80C5-86136E56991B}"/>
                </c:ext>
              </c:extLst>
            </c:dLbl>
            <c:dLbl>
              <c:idx val="6"/>
              <c:layout>
                <c:manualLayout>
                  <c:x val="5.3663088575217188E-3"/>
                  <c:y val="-7.9393289158851743E-2"/>
                </c:manualLayout>
              </c:layout>
              <c:tx>
                <c:rich>
                  <a:bodyPr/>
                  <a:lstStyle/>
                  <a:p>
                    <a:fld id="{6CA0D52B-2505-49CB-A891-B9BDCF4A2B4B}" type="CATEGORYNAME">
                      <a:rPr lang="en-US" altLang="ja-JP" i="1"/>
                      <a:pPr/>
                      <a:t>[CATEGORY NAME]</a:t>
                    </a:fld>
                    <a:r>
                      <a:rPr lang="en-US" altLang="ja-JP" baseline="0"/>
                      <a:t>
1/33(</a:t>
                    </a:r>
                    <a:fld id="{7690C966-28E3-4FE5-8EF6-7A24D955AC9B}" type="PERCENTAGE">
                      <a:rPr lang="en-US" altLang="ja-JP" baseline="0"/>
                      <a:pPr/>
                      <a:t>[PERCENTAGE]</a:t>
                    </a:fld>
                    <a:r>
                      <a:rPr lang="en-US" altLang="ja-JP" baseline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D-76D3-4E0A-80C5-86136E56991B}"/>
                </c:ext>
              </c:extLst>
            </c:dLbl>
            <c:dLbl>
              <c:idx val="7"/>
              <c:layout>
                <c:manualLayout>
                  <c:x val="8.0456530294973044E-2"/>
                  <c:y val="-6.0714248656814913E-2"/>
                </c:manualLayout>
              </c:layout>
              <c:tx>
                <c:rich>
                  <a:bodyPr/>
                  <a:lstStyle/>
                  <a:p>
                    <a:fld id="{36A82269-7FB4-4187-A80A-91508B4A91F5}" type="CATEGORYNAME">
                      <a:rPr lang="en-US" altLang="ja-JP" i="1"/>
                      <a:pPr/>
                      <a:t>[CATEGORY NAME]</a:t>
                    </a:fld>
                    <a:r>
                      <a:rPr lang="en-US" altLang="ja-JP" baseline="0"/>
                      <a:t>
1/33(</a:t>
                    </a:r>
                    <a:fld id="{584BBADA-D82E-4702-960F-EC67239425A7}" type="PERCENTAGE">
                      <a:rPr lang="en-US" altLang="ja-JP" baseline="0"/>
                      <a:pPr/>
                      <a:t>[PERCENTAGE]</a:t>
                    </a:fld>
                    <a:r>
                      <a:rPr lang="en-US" altLang="ja-JP" baseline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F-76D3-4E0A-80C5-86136E56991B}"/>
                </c:ext>
              </c:extLst>
            </c:dLbl>
            <c:dLbl>
              <c:idx val="8"/>
              <c:layout>
                <c:manualLayout>
                  <c:x val="0.1193348758956766"/>
                  <c:y val="-3.7915484656873027E-2"/>
                </c:manualLayout>
              </c:layout>
              <c:tx>
                <c:rich>
                  <a:bodyPr/>
                  <a:lstStyle/>
                  <a:p>
                    <a:fld id="{D2BBCB04-2EBA-4C61-8BA2-07095F31A6DA}" type="CATEGORYNAME">
                      <a:rPr lang="en-US" altLang="ja-JP" i="1"/>
                      <a:pPr/>
                      <a:t>[CATEGORY NAME]</a:t>
                    </a:fld>
                    <a:r>
                      <a:rPr lang="en-US" altLang="ja-JP" baseline="0"/>
                      <a:t>
1/33(</a:t>
                    </a:r>
                    <a:fld id="{7FE63AFF-F782-40F9-AACA-B23F09749D98}" type="PERCENTAGE">
                      <a:rPr lang="en-US" altLang="ja-JP" baseline="0"/>
                      <a:pPr/>
                      <a:t>[PERCENTAGE]</a:t>
                    </a:fld>
                    <a:r>
                      <a:rPr lang="en-US" altLang="ja-JP" baseline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1-76D3-4E0A-80C5-86136E56991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endParaRPr lang="en-US"/>
              </a:p>
            </c:txPr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2!$W$153:$W$161</c:f>
              <c:strCache>
                <c:ptCount val="9"/>
                <c:pt idx="0">
                  <c:v>TP53</c:v>
                </c:pt>
                <c:pt idx="1">
                  <c:v>GNAS</c:v>
                </c:pt>
                <c:pt idx="2">
                  <c:v>SMAD4</c:v>
                </c:pt>
                <c:pt idx="3">
                  <c:v>AR</c:v>
                </c:pt>
                <c:pt idx="4">
                  <c:v>FGFR2</c:v>
                </c:pt>
                <c:pt idx="5">
                  <c:v>IDH1</c:v>
                </c:pt>
                <c:pt idx="6">
                  <c:v>KRAS</c:v>
                </c:pt>
                <c:pt idx="7">
                  <c:v>NRAS</c:v>
                </c:pt>
                <c:pt idx="8">
                  <c:v>RAF1</c:v>
                </c:pt>
              </c:strCache>
            </c:strRef>
          </c:cat>
          <c:val>
            <c:numRef>
              <c:f>Sheet2!$X$153:$X$161</c:f>
              <c:numCache>
                <c:formatCode>General</c:formatCode>
                <c:ptCount val="9"/>
                <c:pt idx="0">
                  <c:v>22</c:v>
                </c:pt>
                <c:pt idx="1">
                  <c:v>3</c:v>
                </c:pt>
                <c:pt idx="2">
                  <c:v>2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76D3-4E0A-80C5-86136E56991B}"/>
            </c:ext>
          </c:extLst>
        </c:ser>
        <c:dLbls>
          <c:showLegendKey val="0"/>
          <c:showVal val="0"/>
          <c:showCatName val="1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673-4E3A-A367-504B886F2C5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673-4E3A-A367-504B886F2C58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673-4E3A-A367-504B886F2C58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673-4E3A-A367-504B886F2C58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673-4E3A-A367-504B886F2C58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D673-4E3A-A367-504B886F2C58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D673-4E3A-A367-504B886F2C58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D673-4E3A-A367-504B886F2C58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D673-4E3A-A367-504B886F2C58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D673-4E3A-A367-504B886F2C58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D673-4E3A-A367-504B886F2C58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D673-4E3A-A367-504B886F2C58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D673-4E3A-A367-504B886F2C58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D673-4E3A-A367-504B886F2C58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D673-4E3A-A367-504B886F2C58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D673-4E3A-A367-504B886F2C58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D673-4E3A-A367-504B886F2C58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D673-4E3A-A367-504B886F2C58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D673-4E3A-A367-504B886F2C58}"/>
              </c:ext>
            </c:extLst>
          </c:dPt>
          <c:dLbls>
            <c:dLbl>
              <c:idx val="0"/>
              <c:layout>
                <c:manualLayout>
                  <c:x val="-0.17982978278135245"/>
                  <c:y val="7.1587096849036668E-3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lang="ja-JP" sz="1400" b="1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defRPr>
                    </a:pPr>
                    <a:fld id="{8BDA8485-63D9-4354-A31D-D14C2B7743CE}" type="CATEGORYNAME">
                      <a:rPr lang="en-US" altLang="ja-JP" sz="1400" i="1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pPr>
                        <a:defRPr lang="ja-JP" sz="1400" b="1">
                          <a:latin typeface="Calibri" panose="020F0502020204030204" pitchFamily="34" charset="0"/>
                          <a:cs typeface="Calibri" panose="020F0502020204030204" pitchFamily="34" charset="0"/>
                        </a:defRPr>
                      </a:pPr>
                      <a:t>[CATEGORY NAME]</a:t>
                    </a:fld>
                    <a:r>
                      <a:rPr lang="en-US" altLang="ja-JP" sz="1400" baseline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
</a:t>
                    </a:r>
                    <a:fld id="{6E432B34-2629-4251-9575-AFAED3502DC6}" type="PERCENTAGE">
                      <a:rPr lang="en-US" altLang="ja-JP" sz="1400" baseline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pPr>
                        <a:defRPr lang="ja-JP" sz="1400" b="1">
                          <a:latin typeface="Calibri" panose="020F0502020204030204" pitchFamily="34" charset="0"/>
                          <a:cs typeface="Calibri" panose="020F0502020204030204" pitchFamily="34" charset="0"/>
                        </a:defRPr>
                      </a:pPr>
                      <a:t>[PERCENTAGE]</a:t>
                    </a:fld>
                    <a:r>
                      <a:rPr lang="en-US" altLang="ja-JP" sz="1400" baseline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(46/93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400" b="1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Calibri" panose="020F0502020204030204" pitchFamily="34" charset="0"/>
                      <a:ea typeface="+mn-ea"/>
                      <a:cs typeface="Calibri" panose="020F0502020204030204" pitchFamily="34" charset="0"/>
                    </a:defRPr>
                  </a:pPr>
                  <a:endParaRPr lang="en-US"/>
                </a:p>
              </c:txPr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6727881453476304"/>
                      <c:h val="0.16657349867208415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D673-4E3A-A367-504B886F2C58}"/>
                </c:ext>
              </c:extLst>
            </c:dLbl>
            <c:dLbl>
              <c:idx val="1"/>
              <c:layout>
                <c:manualLayout>
                  <c:x val="0.15522050360144166"/>
                  <c:y val="-0.1336766169118157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lang="ja-JP" sz="1400" b="1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defRPr>
                    </a:pPr>
                    <a:fld id="{DBF5D01F-2099-432F-8A48-91DC5618FEEC}" type="CATEGORYNAME">
                      <a:rPr lang="en-US" altLang="ja-JP" i="1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pPr>
                        <a:defRPr lang="ja-JP" sz="1400" b="1">
                          <a:latin typeface="Calibri" panose="020F0502020204030204" pitchFamily="34" charset="0"/>
                          <a:cs typeface="Calibri" panose="020F0502020204030204" pitchFamily="34" charset="0"/>
                        </a:defRPr>
                      </a:pPr>
                      <a:t>[CATEGORY NAME]</a:t>
                    </a:fld>
                    <a:r>
                      <a:rPr lang="en-US" altLang="ja-JP" baseline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
</a:t>
                    </a:r>
                    <a:fld id="{42C1C0C8-EB0E-453A-AEF2-7D23076BC8C6}" type="PERCENTAGE">
                      <a:rPr lang="en-US" altLang="ja-JP" baseline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pPr>
                        <a:defRPr lang="ja-JP" sz="1400" b="1">
                          <a:latin typeface="Calibri" panose="020F0502020204030204" pitchFamily="34" charset="0"/>
                          <a:cs typeface="Calibri" panose="020F0502020204030204" pitchFamily="34" charset="0"/>
                        </a:defRPr>
                      </a:pPr>
                      <a:t>[PERCENTAGE]</a:t>
                    </a:fld>
                    <a:r>
                      <a:rPr lang="en-US" altLang="ja-JP" baseline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(12/93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400" b="1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Calibri" panose="020F0502020204030204" pitchFamily="34" charset="0"/>
                      <a:ea typeface="+mn-ea"/>
                      <a:cs typeface="Calibri" panose="020F0502020204030204" pitchFamily="34" charset="0"/>
                    </a:defRPr>
                  </a:pPr>
                  <a:endParaRPr lang="en-US"/>
                </a:p>
              </c:txPr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3895788054432457"/>
                      <c:h val="0.16804678555917835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D673-4E3A-A367-504B886F2C58}"/>
                </c:ext>
              </c:extLst>
            </c:dLbl>
            <c:dLbl>
              <c:idx val="2"/>
              <c:layout>
                <c:manualLayout>
                  <c:x val="0.14043199287773966"/>
                  <c:y val="-9.6940271219161822E-2"/>
                </c:manualLayout>
              </c:layout>
              <c:tx>
                <c:rich>
                  <a:bodyPr/>
                  <a:lstStyle/>
                  <a:p>
                    <a:fld id="{2EB00216-5754-4C1A-8614-2A8DE022696F}" type="CATEGORYNAME">
                      <a:rPr lang="en-US" altLang="ja-JP" i="1"/>
                      <a:pPr/>
                      <a:t>[CATEGORY NAME]</a:t>
                    </a:fld>
                    <a:r>
                      <a:rPr lang="en-US" altLang="ja-JP" baseline="0"/>
                      <a:t>
</a:t>
                    </a:r>
                    <a:fld id="{F57B6311-B8CC-44ED-BAF3-5AAB46D233B2}" type="PERCENTAGE">
                      <a:rPr lang="en-US" altLang="ja-JP" baseline="0"/>
                      <a:pPr/>
                      <a:t>[PERCENTAGE]</a:t>
                    </a:fld>
                    <a:r>
                      <a:rPr lang="en-US" altLang="ja-JP" baseline="0"/>
                      <a:t>(6/93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383776101660317"/>
                      <c:h val="9.9139930110711594E-2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D673-4E3A-A367-504B886F2C58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06CE3F91-7E69-4D9C-A260-3184236FBCA8}" type="CATEGORYNAME">
                      <a:rPr lang="en-US" altLang="ja-JP" i="1"/>
                      <a:pPr/>
                      <a:t>[CATEGORY NAME]</a:t>
                    </a:fld>
                    <a:r>
                      <a:rPr lang="en-US" altLang="ja-JP" baseline="0"/>
                      <a:t>
</a:t>
                    </a:r>
                    <a:fld id="{38A6A113-7F6E-4CC6-9D37-6CCF439EE716}" type="PERCENTAGE">
                      <a:rPr lang="en-US" altLang="ja-JP" baseline="0"/>
                      <a:pPr/>
                      <a:t>[PERCENTAGE]</a:t>
                    </a:fld>
                    <a:r>
                      <a:rPr lang="en-US" altLang="ja-JP" baseline="0"/>
                      <a:t>(6/93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D673-4E3A-A367-504B886F2C58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1A2C1021-F3BB-48C7-BDAD-13E2F6678C16}" type="CATEGORYNAME">
                      <a:rPr lang="en-US" altLang="ja-JP" i="1"/>
                      <a:pPr/>
                      <a:t>[CATEGORY NAME]</a:t>
                    </a:fld>
                    <a:r>
                      <a:rPr lang="en-US" altLang="ja-JP" baseline="0"/>
                      <a:t>
</a:t>
                    </a:r>
                    <a:fld id="{330CDBC9-E4A1-4C0D-86E3-2BB33CE64AB9}" type="PERCENTAGE">
                      <a:rPr lang="en-US" altLang="ja-JP" baseline="0"/>
                      <a:pPr/>
                      <a:t>[PERCENTAGE]</a:t>
                    </a:fld>
                    <a:r>
                      <a:rPr lang="en-US" altLang="ja-JP" baseline="0"/>
                      <a:t>(4/93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D673-4E3A-A367-504B886F2C58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94D64F53-56D0-42A4-988D-C298C21D7311}" type="CATEGORYNAME">
                      <a:rPr lang="en-US" altLang="ja-JP" i="1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pPr/>
                      <a:t>[CATEGORY NAME]</a:t>
                    </a:fld>
                    <a:r>
                      <a:rPr lang="en-US" altLang="ja-JP" baseline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
</a:t>
                    </a:r>
                    <a:fld id="{C1417F41-4F1A-4199-A762-FCE2B7E2E3A4}" type="PERCENTAGE">
                      <a:rPr lang="en-US" altLang="ja-JP" baseline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pPr/>
                      <a:t>[PERCENTAGE]</a:t>
                    </a:fld>
                    <a:r>
                      <a:rPr lang="en-US" altLang="ja-JP" baseline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(3/93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D673-4E3A-A367-504B886F2C58}"/>
                </c:ext>
              </c:extLst>
            </c:dLbl>
            <c:dLbl>
              <c:idx val="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D673-4E3A-A367-504B886F2C58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D673-4E3A-A367-504B886F2C58}"/>
                </c:ext>
              </c:extLst>
            </c:dLbl>
            <c:dLbl>
              <c:idx val="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D673-4E3A-A367-504B886F2C58}"/>
                </c:ext>
              </c:extLst>
            </c:dLbl>
            <c:dLbl>
              <c:idx val="9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3-D673-4E3A-A367-504B886F2C58}"/>
                </c:ext>
              </c:extLst>
            </c:dLbl>
            <c:dLbl>
              <c:idx val="1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D673-4E3A-A367-504B886F2C58}"/>
                </c:ext>
              </c:extLst>
            </c:dLbl>
            <c:dLbl>
              <c:idx val="1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7-D673-4E3A-A367-504B886F2C58}"/>
                </c:ext>
              </c:extLst>
            </c:dLbl>
            <c:dLbl>
              <c:idx val="1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9-D673-4E3A-A367-504B886F2C58}"/>
                </c:ext>
              </c:extLst>
            </c:dLbl>
            <c:dLbl>
              <c:idx val="1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B-D673-4E3A-A367-504B886F2C58}"/>
                </c:ext>
              </c:extLst>
            </c:dLbl>
            <c:dLbl>
              <c:idx val="1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D-D673-4E3A-A367-504B886F2C58}"/>
                </c:ext>
              </c:extLst>
            </c:dLbl>
            <c:dLbl>
              <c:idx val="1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F-D673-4E3A-A367-504B886F2C58}"/>
                </c:ext>
              </c:extLst>
            </c:dLbl>
            <c:dLbl>
              <c:idx val="1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1-D673-4E3A-A367-504B886F2C58}"/>
                </c:ext>
              </c:extLst>
            </c:dLbl>
            <c:dLbl>
              <c:idx val="1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3-D673-4E3A-A367-504B886F2C58}"/>
                </c:ext>
              </c:extLst>
            </c:dLbl>
            <c:dLbl>
              <c:idx val="1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5-D673-4E3A-A367-504B886F2C5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endParaRPr lang="en-US"/>
              </a:p>
            </c:txPr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Feasibilityリキッドのみ S22なし&gt;80'!$A$74:$A$92</c:f>
              <c:strCache>
                <c:ptCount val="19"/>
                <c:pt idx="0">
                  <c:v>TP53</c:v>
                </c:pt>
                <c:pt idx="1">
                  <c:v>KRAS</c:v>
                </c:pt>
                <c:pt idx="2">
                  <c:v>EGFR</c:v>
                </c:pt>
                <c:pt idx="3">
                  <c:v>BRAF</c:v>
                </c:pt>
                <c:pt idx="4">
                  <c:v>MET</c:v>
                </c:pt>
                <c:pt idx="5">
                  <c:v>PIK3CA</c:v>
                </c:pt>
                <c:pt idx="6">
                  <c:v>FGFR3</c:v>
                </c:pt>
                <c:pt idx="7">
                  <c:v>GNAS</c:v>
                </c:pt>
                <c:pt idx="8">
                  <c:v>SF3B1</c:v>
                </c:pt>
                <c:pt idx="9">
                  <c:v>KIT</c:v>
                </c:pt>
                <c:pt idx="10">
                  <c:v>ALK</c:v>
                </c:pt>
                <c:pt idx="11">
                  <c:v>ERBB2</c:v>
                </c:pt>
                <c:pt idx="12">
                  <c:v>ESR1</c:v>
                </c:pt>
                <c:pt idx="13">
                  <c:v>MAP2K1</c:v>
                </c:pt>
                <c:pt idx="14">
                  <c:v>MAP2K2</c:v>
                </c:pt>
                <c:pt idx="15">
                  <c:v>NRAS</c:v>
                </c:pt>
                <c:pt idx="16">
                  <c:v>NTRK1</c:v>
                </c:pt>
                <c:pt idx="17">
                  <c:v>RET</c:v>
                </c:pt>
                <c:pt idx="18">
                  <c:v>SMAD4</c:v>
                </c:pt>
              </c:strCache>
            </c:strRef>
          </c:cat>
          <c:val>
            <c:numRef>
              <c:f>'Feasibilityリキッドのみ S22なし&gt;80'!$C$74:$C$92</c:f>
              <c:numCache>
                <c:formatCode>0%</c:formatCode>
                <c:ptCount val="19"/>
                <c:pt idx="0">
                  <c:v>0.4946236559139785</c:v>
                </c:pt>
                <c:pt idx="1">
                  <c:v>0.12903225806451613</c:v>
                </c:pt>
                <c:pt idx="2">
                  <c:v>6.4516129032258063E-2</c:v>
                </c:pt>
                <c:pt idx="3">
                  <c:v>6.4516129032258063E-2</c:v>
                </c:pt>
                <c:pt idx="4">
                  <c:v>4.3010752688172046E-2</c:v>
                </c:pt>
                <c:pt idx="5">
                  <c:v>3.2258064516129031E-2</c:v>
                </c:pt>
                <c:pt idx="6">
                  <c:v>2.1505376344086023E-2</c:v>
                </c:pt>
                <c:pt idx="7">
                  <c:v>2.1505376344086023E-2</c:v>
                </c:pt>
                <c:pt idx="8">
                  <c:v>2.1505376344086023E-2</c:v>
                </c:pt>
                <c:pt idx="9">
                  <c:v>1.0752688172043012E-2</c:v>
                </c:pt>
                <c:pt idx="10">
                  <c:v>1.0752688172043012E-2</c:v>
                </c:pt>
                <c:pt idx="11">
                  <c:v>1.0752688172043012E-2</c:v>
                </c:pt>
                <c:pt idx="12">
                  <c:v>1.0752688172043012E-2</c:v>
                </c:pt>
                <c:pt idx="13">
                  <c:v>1.0752688172043012E-2</c:v>
                </c:pt>
                <c:pt idx="14">
                  <c:v>1.0752688172043012E-2</c:v>
                </c:pt>
                <c:pt idx="15">
                  <c:v>1.0752688172043012E-2</c:v>
                </c:pt>
                <c:pt idx="16">
                  <c:v>1.0752688172043012E-2</c:v>
                </c:pt>
                <c:pt idx="17">
                  <c:v>1.0752688172043012E-2</c:v>
                </c:pt>
                <c:pt idx="18">
                  <c:v>1.075268817204301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D673-4E3A-A367-504B886F2C58}"/>
            </c:ext>
          </c:extLst>
        </c:ser>
        <c:dLbls>
          <c:showLegendKey val="0"/>
          <c:showVal val="0"/>
          <c:showCatName val="1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920" b="0" i="0" u="none" strike="noStrike" kern="1200" spc="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/>
              <a:t>T stage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920" b="0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１４５例のデータ'!$C$135:$C$137</c:f>
              <c:strCache>
                <c:ptCount val="3"/>
                <c:pt idx="0">
                  <c:v>Tis+1</c:v>
                </c:pt>
                <c:pt idx="1">
                  <c:v>2</c:v>
                </c:pt>
                <c:pt idx="2">
                  <c:v>3</c:v>
                </c:pt>
              </c:strCache>
            </c:strRef>
          </c:cat>
          <c:val>
            <c:numRef>
              <c:f>'１４５例のデータ'!$D$135:$D$137</c:f>
              <c:numCache>
                <c:formatCode>0%</c:formatCode>
                <c:ptCount val="3"/>
                <c:pt idx="0">
                  <c:v>0.41818181818181815</c:v>
                </c:pt>
                <c:pt idx="1">
                  <c:v>0.453125</c:v>
                </c:pt>
                <c:pt idx="2">
                  <c:v>0.576923076923076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201-4818-A044-DDBB83C269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20936975"/>
        <c:axId val="1220919503"/>
      </c:barChart>
      <c:catAx>
        <c:axId val="1220936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220919503"/>
        <c:crosses val="autoZero"/>
        <c:auto val="1"/>
        <c:lblAlgn val="ctr"/>
        <c:lblOffset val="100"/>
        <c:noMultiLvlLbl val="0"/>
      </c:catAx>
      <c:valAx>
        <c:axId val="1220919503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2209369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920" b="0" i="0" u="none" strike="noStrike" kern="1200" spc="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/>
              <a:t>N status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920" b="0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１４５例のデータ'!$J$135:$J$136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cat>
          <c:val>
            <c:numRef>
              <c:f>'１４５例のデータ'!$K$135:$K$136</c:f>
              <c:numCache>
                <c:formatCode>0%</c:formatCode>
                <c:ptCount val="2"/>
                <c:pt idx="0">
                  <c:v>0.43835616438356162</c:v>
                </c:pt>
                <c:pt idx="1">
                  <c:v>0.4861111111111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BC-4716-9448-8412D27751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20918671"/>
        <c:axId val="1220925743"/>
      </c:barChart>
      <c:catAx>
        <c:axId val="12209186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220925743"/>
        <c:crosses val="autoZero"/>
        <c:auto val="1"/>
        <c:lblAlgn val="ctr"/>
        <c:lblOffset val="100"/>
        <c:noMultiLvlLbl val="0"/>
      </c:catAx>
      <c:valAx>
        <c:axId val="1220925743"/>
        <c:scaling>
          <c:orientation val="minMax"/>
          <c:max val="1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22091867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920" b="0" i="0" u="none" strike="noStrike" kern="1200" spc="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/>
              <a:t>M status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920" b="0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１４５例のデータ'!$X$137:$X$138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cat>
          <c:val>
            <c:numRef>
              <c:f>'１４５例のデータ'!$Y$137:$Y$138</c:f>
              <c:numCache>
                <c:formatCode>0%</c:formatCode>
                <c:ptCount val="2"/>
                <c:pt idx="0">
                  <c:v>0.43703703703703706</c:v>
                </c:pt>
                <c:pt idx="1">
                  <c:v>0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369-4EC9-8CE2-C727A08222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5800191"/>
        <c:axId val="515801439"/>
      </c:barChart>
      <c:catAx>
        <c:axId val="5158001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15801439"/>
        <c:crosses val="autoZero"/>
        <c:auto val="1"/>
        <c:lblAlgn val="ctr"/>
        <c:lblOffset val="100"/>
        <c:noMultiLvlLbl val="0"/>
      </c:catAx>
      <c:valAx>
        <c:axId val="515801439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158001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 u="none">
          <a:solidFill>
            <a:schemeClr val="tx1"/>
          </a:solidFill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920" b="0" i="0" u="none" strike="noStrike" kern="1200" spc="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/>
              <a:t>Pathological stage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920" b="0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１４５例のデータ'!$Q$138:$Q$140</c:f>
              <c:strCache>
                <c:ptCount val="3"/>
                <c:pt idx="0">
                  <c:v>0+I</c:v>
                </c:pt>
                <c:pt idx="1">
                  <c:v>II</c:v>
                </c:pt>
                <c:pt idx="2">
                  <c:v>III+IV</c:v>
                </c:pt>
              </c:strCache>
            </c:strRef>
          </c:cat>
          <c:val>
            <c:numRef>
              <c:f>'１４５例のデータ'!$R$138:$R$140</c:f>
              <c:numCache>
                <c:formatCode>0%</c:formatCode>
                <c:ptCount val="3"/>
                <c:pt idx="0">
                  <c:v>0.42622950819672129</c:v>
                </c:pt>
                <c:pt idx="1">
                  <c:v>0.43103448275862066</c:v>
                </c:pt>
                <c:pt idx="2">
                  <c:v>0.615384615384615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D3-4131-B56D-DB45331283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46957503"/>
        <c:axId val="1946957919"/>
      </c:barChart>
      <c:catAx>
        <c:axId val="19469575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946957919"/>
        <c:crosses val="autoZero"/>
        <c:auto val="1"/>
        <c:lblAlgn val="ctr"/>
        <c:lblOffset val="100"/>
        <c:noMultiLvlLbl val="0"/>
      </c:catAx>
      <c:valAx>
        <c:axId val="1946957919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9469575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920" b="0" i="0" u="none" strike="noStrike" kern="1200" spc="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/>
              <a:t>CA19-9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920" b="0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１４５例のデータ'!$AE$136:$AE$137</c:f>
              <c:strCache>
                <c:ptCount val="2"/>
                <c:pt idx="0">
                  <c:v>low (less or equal than 37)</c:v>
                </c:pt>
                <c:pt idx="1">
                  <c:v>high (more than 37)</c:v>
                </c:pt>
              </c:strCache>
            </c:strRef>
          </c:cat>
          <c:val>
            <c:numRef>
              <c:f>'１４５例のデータ'!$AF$136:$AF$137</c:f>
              <c:numCache>
                <c:formatCode>0%</c:formatCode>
                <c:ptCount val="2"/>
                <c:pt idx="0">
                  <c:v>0.40740740740740738</c:v>
                </c:pt>
                <c:pt idx="1">
                  <c:v>0.476744186046511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C09-4A4C-B3D0-E935A30C36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39355615"/>
        <c:axId val="739356031"/>
      </c:barChart>
      <c:catAx>
        <c:axId val="73935561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739356031"/>
        <c:crosses val="autoZero"/>
        <c:auto val="1"/>
        <c:lblAlgn val="ctr"/>
        <c:lblOffset val="100"/>
        <c:noMultiLvlLbl val="0"/>
      </c:catAx>
      <c:valAx>
        <c:axId val="739356031"/>
        <c:scaling>
          <c:orientation val="minMax"/>
          <c:max val="1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73935561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6060E8-E740-4B72-B9DD-2D261EF6384E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9AD4AD-DFE1-4D46-B228-275DB010E3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17576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Less than 5 53 (901)</a:t>
            </a:r>
          </a:p>
          <a:p>
            <a:r>
              <a:rPr kumimoji="1" lang="en-US" altLang="ja-JP" dirty="0"/>
              <a:t>More or equal than 5 92 (818)</a:t>
            </a:r>
          </a:p>
          <a:p>
            <a:r>
              <a:rPr kumimoji="1" lang="en-US" altLang="ja-JP" dirty="0"/>
              <a:t>Log-rank 0.9064 </a:t>
            </a: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9AD4AD-DFE1-4D46-B228-275DB010E36D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81389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 S4 Genomic landscape of matched cell-free total nucleic acid (</a:t>
            </a:r>
            <a:r>
              <a:rPr kumimoji="1" lang="en-US" altLang="ja-JP" dirty="0" err="1"/>
              <a:t>cfTNA</a:t>
            </a:r>
            <a:r>
              <a:rPr kumimoji="1" lang="en-US" altLang="ja-JP" dirty="0"/>
              <a:t>)-white blood cell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648E195-63A2-4383-8141-14597F3EF228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088616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31546F-85A1-43FF-A171-9A3A762216C9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939941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9AD4AD-DFE1-4D46-B228-275DB010E36D}" type="slidenum">
              <a:rPr kumimoji="1" lang="ja-JP" altLang="en-US" smtClean="0"/>
              <a:t>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14801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EF19C7-4B8A-47D3-B572-C42D05F0DFE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C0BC62E-1425-473C-B0C4-3CD0B69E93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40CCA80-413E-489C-B063-1A0AF9BF02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37D9D-72DB-407A-B00C-7BC469549EA2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0DC8579-BA22-491F-B41D-DF39CB6F9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4CB219-F39F-49EE-B702-A7B993C4C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BA35-972B-4677-AE65-49BB212F6F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6870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AD5BC7-4DD0-44BC-9081-6105087237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BE9BB8C-A227-404A-9868-BE198AD713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B1CCFE5-29E2-4B2D-BBD5-AF49F473FE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37D9D-72DB-407A-B00C-7BC469549EA2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9F73601-B281-46F9-8173-7712159759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223E58A-D6C8-479A-9FCC-C839411FF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BA35-972B-4677-AE65-49BB212F6F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578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992C503-ED42-42C7-8B54-40D2ACEA6C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DBE3D7B-8056-4F5C-AA75-90C04DB729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8E13F9-E0DD-42AD-9220-AFEB9189F5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37D9D-72DB-407A-B00C-7BC469549EA2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B29CFD7-A3B6-4924-8E98-B44D01A0B7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28A9D3C-CA74-4F1E-BA10-25B840F6A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BA35-972B-4677-AE65-49BB212F6F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66984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7B29B3-7835-44C4-807A-193A3D7A2C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FE0EE4F-8FF4-4355-AF48-A63A64FC09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C8198ED-F85C-4503-A4DF-6C7C372653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37D9D-72DB-407A-B00C-7BC469549EA2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2A6236E-DBB7-4649-A716-155F5E3013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F9D72C-0F89-4BB2-9838-78806C8BDC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BA35-972B-4677-AE65-49BB212F6F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0525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A8C6D0-8F86-4920-A8C6-0A6EA92F06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BA6B5CA-0A66-40A4-8356-3EDED510EE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3ADD46D-CC03-4EA8-8087-20E28225C9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37D9D-72DB-407A-B00C-7BC469549EA2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611C139-1BB3-438A-AE0D-55C8FC241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242E533-AC3E-40FD-B6E9-455BB57388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BA35-972B-4677-AE65-49BB212F6F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1427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323463-B91B-49DF-8B8F-250A979A63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27F2C8C-2290-457E-B6ED-6A76E40CD6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911BCD9-A22D-4FB7-AC2A-7C78D462A2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C0DEF55-48D6-498C-B8A3-2EBF51A80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37D9D-72DB-407A-B00C-7BC469549EA2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ECF6663-799A-4A23-9CE3-60349C0EE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FEC36BF-E238-4309-BCC0-FF3A84C94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BA35-972B-4677-AE65-49BB212F6F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2879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ABC9CC-AC36-41DA-A498-6D5C74E546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DEEC014-BF4C-4C3C-986B-D51A1C1655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A63F0E4-8829-407B-8C2A-4249B87BDA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A2A5E4E-4490-4D0B-B1CC-0FA776EF79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85C205E-1817-42F8-BC32-1542AD2451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C8D74F6-E47E-4760-884E-4A84B1F923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37D9D-72DB-407A-B00C-7BC469549EA2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676C60F-3D7C-478F-9906-B83C13D728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2897AE6-05CF-48C6-AF92-E0C1D08D9A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BA35-972B-4677-AE65-49BB212F6F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065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15F18F3-6D5F-4C98-BA99-9E3F834D93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9A575C5-7674-4EA1-8317-60FBAA0D9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37D9D-72DB-407A-B00C-7BC469549EA2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F2B35DA-F9D6-4E8C-8EB2-6E325D7F3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163005D-982E-4481-A6E8-CC41FF386D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BA35-972B-4677-AE65-49BB212F6F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6591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446756F-EB7A-4AB4-A7EE-7F2F22CED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37D9D-72DB-407A-B00C-7BC469549EA2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AC4C014-081A-4F6F-8EA2-27A1C0B457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AB2B6D3-153A-4F03-8218-CCCFB411F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BA35-972B-4677-AE65-49BB212F6F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7215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994156A-E71A-4AA8-85CB-E5756A4CAB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5FAAF91-EB4B-449F-A5CB-768BD24441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CCB97F2-DCB0-44B2-9BBB-E402E24EE1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B32AE87-6BBD-4D8E-9CD3-D37FBE86F0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37D9D-72DB-407A-B00C-7BC469549EA2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FDF080C-B632-4EFF-ADAE-1BB395AC5C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E7BCA2D-0837-4303-ACD7-C30BBC96D7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BA35-972B-4677-AE65-49BB212F6F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454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B34EC0-004C-4C5D-8BD3-9734E650CA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70D4785-76B5-45F7-90BD-B6B5B8F63D9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7D42B7F-CF3F-4106-A6CE-4BA50283D9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B90F929-9B98-4D93-A770-6ADBEDF7E8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37D9D-72DB-407A-B00C-7BC469549EA2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D998318-9CC2-4082-BC63-36F882B67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FCCA0E4-05D4-48F6-B918-7CFB9CDB8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6BA35-972B-4677-AE65-49BB212F6F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1902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E4046ED-5DCD-4572-82CA-7FBD937355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109E2B9-36F9-4E63-8BA1-F3CFC1AD60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80E2CC-C394-4C79-A36B-A19577BFFE1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537D9D-72DB-407A-B00C-7BC469549EA2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A3C405-19C3-45B4-A80B-B50E97A4FB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7EA2D7B-99B0-4F6B-A7D2-5FE08EBFEB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F6BA35-972B-4677-AE65-49BB212F6F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6428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3AD7CA1-F628-483C-91AF-1D61408882F6}"/>
              </a:ext>
            </a:extLst>
          </p:cNvPr>
          <p:cNvSpPr txBox="1"/>
          <p:nvPr/>
        </p:nvSpPr>
        <p:spPr>
          <a:xfrm>
            <a:off x="119742" y="1067191"/>
            <a:ext cx="11985171" cy="24314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latin typeface="Calibri" panose="020F0502020204030204" pitchFamily="34" charset="0"/>
                <a:cs typeface="Calibri" panose="020F0502020204030204" pitchFamily="34" charset="0"/>
              </a:rPr>
              <a:t>Title : Tumor informed approach improved detection rate of </a:t>
            </a:r>
            <a:r>
              <a:rPr kumimoji="1" lang="en-US" altLang="ja-JP" sz="2000" b="1" dirty="0" err="1">
                <a:latin typeface="Calibri" panose="020F0502020204030204" pitchFamily="34" charset="0"/>
                <a:cs typeface="Calibri" panose="020F0502020204030204" pitchFamily="34" charset="0"/>
              </a:rPr>
              <a:t>ctDNA</a:t>
            </a:r>
            <a:r>
              <a:rPr kumimoji="1" lang="en-US" altLang="ja-JP" sz="2000" b="1" dirty="0">
                <a:latin typeface="Calibri" panose="020F0502020204030204" pitchFamily="34" charset="0"/>
                <a:cs typeface="Calibri" panose="020F0502020204030204" pitchFamily="34" charset="0"/>
              </a:rPr>
              <a:t> in operable pancreatic cancer</a:t>
            </a:r>
          </a:p>
          <a:p>
            <a:pPr algn="ctr"/>
            <a:endParaRPr kumimoji="1" lang="en-US" altLang="ja-JP" sz="20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r>
              <a:rPr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S</a:t>
            </a:r>
            <a:r>
              <a:rPr kumimoji="1"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upplement</a:t>
            </a:r>
            <a:r>
              <a:rPr lang="ja-JP" altLang="en-US" sz="20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Figure</a:t>
            </a:r>
          </a:p>
          <a:p>
            <a:pPr algn="ctr"/>
            <a:endParaRPr lang="en-US" altLang="ja-JP" sz="20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/>
            <a:r>
              <a:rPr lang="en-US" altLang="ja-JP" sz="1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Calibri" panose="020F0502020204030204" pitchFamily="34" charset="0"/>
              </a:rPr>
              <a:t>Figure S1. Survival curves for RFS stratified by </a:t>
            </a:r>
            <a:r>
              <a:rPr lang="en-US" altLang="ja-JP" sz="1800" i="1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Calibri" panose="020F0502020204030204" pitchFamily="34" charset="0"/>
              </a:rPr>
              <a:t>TP53</a:t>
            </a:r>
            <a:r>
              <a:rPr lang="en-US" altLang="ja-JP" sz="1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Calibri" panose="020F0502020204030204" pitchFamily="34" charset="0"/>
              </a:rPr>
              <a:t> status detected in tumor</a:t>
            </a:r>
            <a:endParaRPr lang="ja-JP" altLang="ja-JP" sz="1800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  <a:p>
            <a:pPr algn="just"/>
            <a:r>
              <a:rPr lang="en-US" altLang="ja-JP" sz="1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Calibri" panose="020F0502020204030204" pitchFamily="34" charset="0"/>
              </a:rPr>
              <a:t>Figure S2. Genomic landscape of matched cell-free total nucleic acid (</a:t>
            </a:r>
            <a:r>
              <a:rPr lang="en-US" altLang="ja-JP" sz="18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Calibri" panose="020F0502020204030204" pitchFamily="34" charset="0"/>
              </a:rPr>
              <a:t>cfTNA</a:t>
            </a:r>
            <a:r>
              <a:rPr lang="en-US" altLang="ja-JP" sz="1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Calibri" panose="020F0502020204030204" pitchFamily="34" charset="0"/>
              </a:rPr>
              <a:t>) - buffy coat</a:t>
            </a:r>
            <a:endParaRPr lang="ja-JP" altLang="ja-JP" sz="1800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  <a:p>
            <a:pPr algn="just"/>
            <a:r>
              <a:rPr lang="en-US" altLang="ja-JP" sz="1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Calibri" panose="020F0502020204030204" pitchFamily="34" charset="0"/>
              </a:rPr>
              <a:t>Figure S3. Genomic landscape of circulating tumor DNA (</a:t>
            </a:r>
            <a:r>
              <a:rPr lang="en-US" altLang="ja-JP" sz="18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Calibri" panose="020F0502020204030204" pitchFamily="34" charset="0"/>
              </a:rPr>
              <a:t>ctDNA</a:t>
            </a:r>
            <a:r>
              <a:rPr lang="en-US" altLang="ja-JP" sz="1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Calibri" panose="020F0502020204030204" pitchFamily="34" charset="0"/>
              </a:rPr>
              <a:t>) from pancreatic cancer </a:t>
            </a:r>
            <a:endParaRPr lang="ja-JP" altLang="ja-JP" sz="1800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  <a:p>
            <a:pPr algn="just"/>
            <a:r>
              <a:rPr lang="en-US" altLang="ja-JP" sz="1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Calibri" panose="020F0502020204030204" pitchFamily="34" charset="0"/>
              </a:rPr>
              <a:t>Figure S4. Association between clinicopathological features and </a:t>
            </a:r>
            <a:r>
              <a:rPr lang="en-US" altLang="ja-JP" sz="18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Calibri" panose="020F0502020204030204" pitchFamily="34" charset="0"/>
              </a:rPr>
              <a:t>ctDNA</a:t>
            </a:r>
            <a:r>
              <a:rPr lang="en-US" altLang="ja-JP" sz="1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Calibri" panose="020F0502020204030204" pitchFamily="34" charset="0"/>
              </a:rPr>
              <a:t> detection </a:t>
            </a:r>
            <a:endParaRPr lang="ja-JP" altLang="ja-JP" sz="1800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0422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B0C8705-E0C1-43C2-B8D1-6D58A7F856C1}"/>
              </a:ext>
            </a:extLst>
          </p:cNvPr>
          <p:cNvSpPr txBox="1"/>
          <p:nvPr/>
        </p:nvSpPr>
        <p:spPr>
          <a:xfrm>
            <a:off x="466725" y="5668180"/>
            <a:ext cx="11616418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Figure S1.</a:t>
            </a:r>
            <a:r>
              <a:rPr lang="ja-JP" altLang="en-US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Survival curves for RFS stratified by </a:t>
            </a:r>
            <a:r>
              <a:rPr lang="en-US" altLang="ja-JP" i="1" dirty="0">
                <a:latin typeface="Calibri" panose="020F0502020204030204" pitchFamily="34" charset="0"/>
                <a:cs typeface="Calibri" panose="020F0502020204030204" pitchFamily="34" charset="0"/>
              </a:rPr>
              <a:t>TP53</a:t>
            </a:r>
            <a:r>
              <a:rPr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 status detected in tumor.</a:t>
            </a:r>
          </a:p>
          <a:p>
            <a:r>
              <a:rPr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The numbers below represent the number of recurrence-free cases at each time point (0, 200, 400, 600, 800, 1,000 days).</a:t>
            </a:r>
          </a:p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RFS was significantly shorter in cases with </a:t>
            </a:r>
            <a:r>
              <a:rPr kumimoji="1" lang="en-US" altLang="ja-JP" i="1" dirty="0">
                <a:latin typeface="Calibri" panose="020F0502020204030204" pitchFamily="34" charset="0"/>
                <a:cs typeface="Calibri" panose="020F0502020204030204" pitchFamily="34" charset="0"/>
              </a:rPr>
              <a:t>TP53 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positive than in those with </a:t>
            </a:r>
            <a:r>
              <a:rPr kumimoji="1" lang="en-US" altLang="ja-JP" i="1" dirty="0">
                <a:latin typeface="Calibri" panose="020F0502020204030204" pitchFamily="34" charset="0"/>
                <a:cs typeface="Calibri" panose="020F0502020204030204" pitchFamily="34" charset="0"/>
              </a:rPr>
              <a:t>TP53 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negative (p=0.0245).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7C86F115-2306-94FA-87DA-D88C72E614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36057" y="543489"/>
            <a:ext cx="5584420" cy="45967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0824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4CB8408-B569-411B-832B-1DF241DC5DDF}"/>
              </a:ext>
            </a:extLst>
          </p:cNvPr>
          <p:cNvSpPr txBox="1"/>
          <p:nvPr/>
        </p:nvSpPr>
        <p:spPr>
          <a:xfrm>
            <a:off x="1809892" y="5566507"/>
            <a:ext cx="1023486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Figure S2. 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Genomic landscape of matched cell-free total nucleic acid (</a:t>
            </a:r>
            <a:r>
              <a:rPr kumimoji="1" lang="en-US" altLang="ja-JP" dirty="0" err="1">
                <a:latin typeface="Calibri" panose="020F0502020204030204" pitchFamily="34" charset="0"/>
                <a:cs typeface="Calibri" panose="020F0502020204030204" pitchFamily="34" charset="0"/>
              </a:rPr>
              <a:t>cfTNA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)-buffy coat</a:t>
            </a:r>
          </a:p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Pie chart indicating CH related mutations detected in buffy coat.</a:t>
            </a:r>
            <a:endParaRPr kumimoji="1"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9EFB5397-72A7-338F-7800-28DB1A2770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9218784"/>
              </p:ext>
            </p:extLst>
          </p:nvPr>
        </p:nvGraphicFramePr>
        <p:xfrm>
          <a:off x="2778522" y="1051759"/>
          <a:ext cx="6440123" cy="411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5981897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A0DDE4D-8C0D-4DAD-83BE-7C8937277312}"/>
              </a:ext>
            </a:extLst>
          </p:cNvPr>
          <p:cNvSpPr txBox="1"/>
          <p:nvPr/>
        </p:nvSpPr>
        <p:spPr>
          <a:xfrm>
            <a:off x="207690" y="6009302"/>
            <a:ext cx="93630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Figure S3. 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Genomic landscape of </a:t>
            </a:r>
            <a:r>
              <a:rPr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circulating tumor 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DNA (</a:t>
            </a:r>
            <a:r>
              <a:rPr kumimoji="1" lang="en-US" altLang="ja-JP" dirty="0" err="1">
                <a:latin typeface="Calibri" panose="020F0502020204030204" pitchFamily="34" charset="0"/>
                <a:cs typeface="Calibri" panose="020F0502020204030204" pitchFamily="34" charset="0"/>
              </a:rPr>
              <a:t>ctDNA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) from pancreatic cancer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971F94E-28DB-4ECF-86D9-4AEF3E098BF9}"/>
              </a:ext>
            </a:extLst>
          </p:cNvPr>
          <p:cNvSpPr txBox="1"/>
          <p:nvPr/>
        </p:nvSpPr>
        <p:spPr>
          <a:xfrm>
            <a:off x="124870" y="6315670"/>
            <a:ext cx="119422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Overall distribution of mutations calculated as number of mutations per gene over the total </a:t>
            </a:r>
            <a:r>
              <a:rPr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9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3 mutations.</a:t>
            </a:r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110EED18-9F09-F5B4-8A95-C8373AAB93F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8118990"/>
              </p:ext>
            </p:extLst>
          </p:nvPr>
        </p:nvGraphicFramePr>
        <p:xfrm>
          <a:off x="3394042" y="1294841"/>
          <a:ext cx="4663688" cy="4137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4606522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7DE4889-9B86-40C5-B4E5-CA83A8C62ECC}"/>
              </a:ext>
            </a:extLst>
          </p:cNvPr>
          <p:cNvSpPr txBox="1"/>
          <p:nvPr/>
        </p:nvSpPr>
        <p:spPr>
          <a:xfrm>
            <a:off x="309855" y="5622577"/>
            <a:ext cx="112421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Figure S4. </a:t>
            </a:r>
            <a:r>
              <a:rPr kumimoji="1" lang="en-US" altLang="ja-JP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rPr>
              <a:t>Association</a:t>
            </a: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rPr>
              <a:t> between clinicopathological features and </a:t>
            </a:r>
            <a:r>
              <a:rPr kumimoji="1" lang="en-US" altLang="ja-JP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rPr>
              <a:t>ctDNA</a:t>
            </a: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rPr>
              <a:t> detection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FAE0BA8-FFEE-4E67-BD1C-F8DC605C4509}"/>
              </a:ext>
            </a:extLst>
          </p:cNvPr>
          <p:cNvSpPr txBox="1"/>
          <p:nvPr/>
        </p:nvSpPr>
        <p:spPr>
          <a:xfrm>
            <a:off x="229766" y="6040538"/>
            <a:ext cx="1173246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ja-JP" altLang="en-US" dirty="0">
                <a:latin typeface="Calibri" panose="020F0502020204030204" pitchFamily="34" charset="0"/>
                <a:cs typeface="Calibri" panose="020F0502020204030204" pitchFamily="34" charset="0"/>
              </a:rPr>
              <a:t>（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A) </a:t>
            </a:r>
            <a:r>
              <a:rPr kumimoji="1" lang="en-US" altLang="ja-JP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rPr>
              <a:t>Association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 between T stage and </a:t>
            </a:r>
            <a:r>
              <a:rPr kumimoji="1" lang="en-US" altLang="ja-JP" dirty="0" err="1">
                <a:latin typeface="Calibri" panose="020F0502020204030204" pitchFamily="34" charset="0"/>
                <a:cs typeface="Calibri" panose="020F0502020204030204" pitchFamily="34" charset="0"/>
              </a:rPr>
              <a:t>ctDNA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 detection.</a:t>
            </a:r>
            <a:endParaRPr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BFB277C-6D93-48EE-BD5E-348DA3FB0856}"/>
              </a:ext>
            </a:extLst>
          </p:cNvPr>
          <p:cNvSpPr txBox="1"/>
          <p:nvPr/>
        </p:nvSpPr>
        <p:spPr>
          <a:xfrm>
            <a:off x="6694715" y="2072503"/>
            <a:ext cx="204898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Pearson’s χ</a:t>
            </a:r>
            <a:r>
              <a:rPr lang="en-US" altLang="ja-JP" sz="16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 test</a:t>
            </a:r>
            <a:endParaRPr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p=0.4015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3B33503-FBEA-573B-1F34-A07809A4826C}"/>
              </a:ext>
            </a:extLst>
          </p:cNvPr>
          <p:cNvSpPr txBox="1"/>
          <p:nvPr/>
        </p:nvSpPr>
        <p:spPr>
          <a:xfrm>
            <a:off x="4622798" y="4638540"/>
            <a:ext cx="10329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N=55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07FF3B7-75F3-3B30-A106-EB8BE5544273}"/>
              </a:ext>
            </a:extLst>
          </p:cNvPr>
          <p:cNvSpPr txBox="1"/>
          <p:nvPr/>
        </p:nvSpPr>
        <p:spPr>
          <a:xfrm>
            <a:off x="7569198" y="4638540"/>
            <a:ext cx="10329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N=26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93A3342-33B7-5854-8CC8-D1E5BA9C354E}"/>
              </a:ext>
            </a:extLst>
          </p:cNvPr>
          <p:cNvSpPr txBox="1"/>
          <p:nvPr/>
        </p:nvSpPr>
        <p:spPr>
          <a:xfrm>
            <a:off x="6087536" y="4638540"/>
            <a:ext cx="10329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N=64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599158E3-07F0-B991-05AE-6D458512BC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2741318"/>
              </p:ext>
            </p:extLst>
          </p:nvPr>
        </p:nvGraphicFramePr>
        <p:xfrm>
          <a:off x="3483429" y="2057400"/>
          <a:ext cx="526027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5245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F2BCDE9-BCFC-495A-BF04-FC7A8863D6D9}"/>
              </a:ext>
            </a:extLst>
          </p:cNvPr>
          <p:cNvSpPr txBox="1"/>
          <p:nvPr/>
        </p:nvSpPr>
        <p:spPr>
          <a:xfrm>
            <a:off x="229766" y="6040538"/>
            <a:ext cx="1173246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ja-JP" altLang="en-US" dirty="0">
                <a:latin typeface="Calibri" panose="020F0502020204030204" pitchFamily="34" charset="0"/>
                <a:cs typeface="Calibri" panose="020F0502020204030204" pitchFamily="34" charset="0"/>
              </a:rPr>
              <a:t>（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B)</a:t>
            </a:r>
            <a:r>
              <a:rPr lang="ja-JP" altLang="en-US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1" lang="en-US" altLang="ja-JP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rPr>
              <a:t>Association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 between N status and </a:t>
            </a:r>
            <a:r>
              <a:rPr kumimoji="1" lang="en-US" altLang="ja-JP" dirty="0" err="1">
                <a:latin typeface="Calibri" panose="020F0502020204030204" pitchFamily="34" charset="0"/>
                <a:cs typeface="Calibri" panose="020F0502020204030204" pitchFamily="34" charset="0"/>
              </a:rPr>
              <a:t>ctDNA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 detection.</a:t>
            </a:r>
            <a:endParaRPr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817E652-9045-4960-A80C-ECC72935CF27}"/>
              </a:ext>
            </a:extLst>
          </p:cNvPr>
          <p:cNvSpPr txBox="1"/>
          <p:nvPr/>
        </p:nvSpPr>
        <p:spPr>
          <a:xfrm>
            <a:off x="6520543" y="2095500"/>
            <a:ext cx="20290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Pearson’s χ</a:t>
            </a:r>
            <a:r>
              <a:rPr lang="en-US" altLang="ja-JP" sz="16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 test</a:t>
            </a:r>
            <a:endParaRPr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p=0.5641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707AB09-BE6E-03F1-37DD-FEF6614ED138}"/>
              </a:ext>
            </a:extLst>
          </p:cNvPr>
          <p:cNvSpPr txBox="1"/>
          <p:nvPr/>
        </p:nvSpPr>
        <p:spPr>
          <a:xfrm>
            <a:off x="5143822" y="4672830"/>
            <a:ext cx="10329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N=73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AC446CA-F97A-D043-5832-82E3A5821EDB}"/>
              </a:ext>
            </a:extLst>
          </p:cNvPr>
          <p:cNvSpPr txBox="1"/>
          <p:nvPr/>
        </p:nvSpPr>
        <p:spPr>
          <a:xfrm>
            <a:off x="7024074" y="4672830"/>
            <a:ext cx="10329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N=72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84970843-492E-7BEA-CFEF-7D2338DD78C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2555868"/>
              </p:ext>
            </p:extLst>
          </p:nvPr>
        </p:nvGraphicFramePr>
        <p:xfrm>
          <a:off x="3810000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6976688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5B27C633-F4A5-84EB-CCAC-27C5F7450E4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2815768"/>
              </p:ext>
            </p:extLst>
          </p:nvPr>
        </p:nvGraphicFramePr>
        <p:xfrm>
          <a:off x="3810000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2D39975-3570-4DF2-B42E-6CD253FE7939}"/>
              </a:ext>
            </a:extLst>
          </p:cNvPr>
          <p:cNvSpPr txBox="1"/>
          <p:nvPr/>
        </p:nvSpPr>
        <p:spPr>
          <a:xfrm>
            <a:off x="229766" y="6040538"/>
            <a:ext cx="1173246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(C) </a:t>
            </a:r>
            <a:r>
              <a:rPr kumimoji="1" lang="en-US" altLang="ja-JP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rPr>
              <a:t>Association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 between M status and </a:t>
            </a:r>
            <a:r>
              <a:rPr kumimoji="1" lang="en-US" altLang="ja-JP" dirty="0" err="1">
                <a:latin typeface="Calibri" panose="020F0502020204030204" pitchFamily="34" charset="0"/>
                <a:cs typeface="Calibri" panose="020F0502020204030204" pitchFamily="34" charset="0"/>
              </a:rPr>
              <a:t>ctDNA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 detection. </a:t>
            </a:r>
            <a:endParaRPr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C2D04AE-C1E7-CAB2-93B6-81EC63BB0AE3}"/>
              </a:ext>
            </a:extLst>
          </p:cNvPr>
          <p:cNvSpPr txBox="1"/>
          <p:nvPr/>
        </p:nvSpPr>
        <p:spPr>
          <a:xfrm>
            <a:off x="6462487" y="2057400"/>
            <a:ext cx="191951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Pearson’s χ</a:t>
            </a:r>
            <a:r>
              <a:rPr lang="en-US" altLang="ja-JP" sz="16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 test</a:t>
            </a:r>
            <a:endParaRPr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p=0.0263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E4C5B2B-503C-E284-BF6D-F52FCF867D93}"/>
              </a:ext>
            </a:extLst>
          </p:cNvPr>
          <p:cNvSpPr txBox="1"/>
          <p:nvPr/>
        </p:nvSpPr>
        <p:spPr>
          <a:xfrm>
            <a:off x="5063066" y="4631323"/>
            <a:ext cx="10329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N=135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2FBAC5E-33AB-9E4B-4BE2-ADAA595A8526}"/>
              </a:ext>
            </a:extLst>
          </p:cNvPr>
          <p:cNvSpPr txBox="1"/>
          <p:nvPr/>
        </p:nvSpPr>
        <p:spPr>
          <a:xfrm>
            <a:off x="7040107" y="4631323"/>
            <a:ext cx="10329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N=1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38384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111E516A-F217-D7EA-AB55-AD29506F416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1359629"/>
              </p:ext>
            </p:extLst>
          </p:nvPr>
        </p:nvGraphicFramePr>
        <p:xfrm>
          <a:off x="3468913" y="2057400"/>
          <a:ext cx="5268687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2D39975-3570-4DF2-B42E-6CD253FE7939}"/>
              </a:ext>
            </a:extLst>
          </p:cNvPr>
          <p:cNvSpPr txBox="1"/>
          <p:nvPr/>
        </p:nvSpPr>
        <p:spPr>
          <a:xfrm>
            <a:off x="229766" y="6040538"/>
            <a:ext cx="1173246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(D) </a:t>
            </a:r>
            <a:r>
              <a:rPr kumimoji="1" lang="en-US" altLang="ja-JP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rPr>
              <a:t>Association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 between </a:t>
            </a:r>
            <a:r>
              <a:rPr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pathological 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stage and </a:t>
            </a:r>
            <a:r>
              <a:rPr kumimoji="1" lang="en-US" altLang="ja-JP" dirty="0" err="1">
                <a:latin typeface="Calibri" panose="020F0502020204030204" pitchFamily="34" charset="0"/>
                <a:cs typeface="Calibri" panose="020F0502020204030204" pitchFamily="34" charset="0"/>
              </a:rPr>
              <a:t>ctDNA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 detection</a:t>
            </a:r>
            <a:r>
              <a:rPr kumimoji="1" lang="en-US" altLang="ja-JP"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endParaRPr lang="ja-JP" altLang="en-US" sz="1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69B0319-140B-77FE-D3F3-ED39CABD10AC}"/>
              </a:ext>
            </a:extLst>
          </p:cNvPr>
          <p:cNvSpPr txBox="1"/>
          <p:nvPr/>
        </p:nvSpPr>
        <p:spPr>
          <a:xfrm>
            <a:off x="6781801" y="2057400"/>
            <a:ext cx="195579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Pearson’s χ</a:t>
            </a:r>
            <a:r>
              <a:rPr lang="en-US" altLang="ja-JP" sz="16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 test</a:t>
            </a:r>
            <a:endParaRPr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p=0.2233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8FD0AD6-7344-8964-2855-B0B5EDB48618}"/>
              </a:ext>
            </a:extLst>
          </p:cNvPr>
          <p:cNvSpPr txBox="1"/>
          <p:nvPr/>
        </p:nvSpPr>
        <p:spPr>
          <a:xfrm>
            <a:off x="4622798" y="4752840"/>
            <a:ext cx="10329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N=61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E75477E-E885-D8CF-9BD0-1CF3B6FAF216}"/>
              </a:ext>
            </a:extLst>
          </p:cNvPr>
          <p:cNvSpPr txBox="1"/>
          <p:nvPr/>
        </p:nvSpPr>
        <p:spPr>
          <a:xfrm>
            <a:off x="7569198" y="4752840"/>
            <a:ext cx="10329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N=26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04F3AC4-3E97-CC87-0507-ADC8FE702871}"/>
              </a:ext>
            </a:extLst>
          </p:cNvPr>
          <p:cNvSpPr txBox="1"/>
          <p:nvPr/>
        </p:nvSpPr>
        <p:spPr>
          <a:xfrm>
            <a:off x="6087536" y="4752840"/>
            <a:ext cx="10329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N=58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961230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F8FB4B8F-D0A2-DF0B-3CCD-1C40971452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3701056"/>
              </p:ext>
            </p:extLst>
          </p:nvPr>
        </p:nvGraphicFramePr>
        <p:xfrm>
          <a:off x="3135085" y="2057400"/>
          <a:ext cx="557348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EB6AAEC-5E76-4C17-B6D3-027B69737E5F}"/>
              </a:ext>
            </a:extLst>
          </p:cNvPr>
          <p:cNvSpPr txBox="1"/>
          <p:nvPr/>
        </p:nvSpPr>
        <p:spPr>
          <a:xfrm>
            <a:off x="300737" y="5168933"/>
            <a:ext cx="112421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(E) </a:t>
            </a:r>
            <a:r>
              <a:rPr kumimoji="1" lang="en-US" altLang="ja-JP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rPr>
              <a:t>Association</a:t>
            </a: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rPr>
              <a:t> between CA19-9 and </a:t>
            </a:r>
            <a:r>
              <a:rPr kumimoji="1" lang="en-US" altLang="ja-JP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rPr>
              <a:t>ctDNA</a:t>
            </a: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rPr>
              <a:t> detection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2D39975-3570-4DF2-B42E-6CD253FE7939}"/>
              </a:ext>
            </a:extLst>
          </p:cNvPr>
          <p:cNvSpPr txBox="1"/>
          <p:nvPr/>
        </p:nvSpPr>
        <p:spPr>
          <a:xfrm>
            <a:off x="229766" y="5622577"/>
            <a:ext cx="11732467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These bars indicated the </a:t>
            </a:r>
            <a:r>
              <a:rPr kumimoji="1" lang="en-US" altLang="ja-JP" dirty="0" err="1">
                <a:latin typeface="Calibri" panose="020F0502020204030204" pitchFamily="34" charset="0"/>
                <a:cs typeface="Calibri" panose="020F0502020204030204" pitchFamily="34" charset="0"/>
              </a:rPr>
              <a:t>ctDNA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 detection rate by classification of (A) T, (B) N, (C) M, (D) pathological Stage and (E) CA19-9 values. Number of patients shown below each corresponding bar. All p-values were calculated using </a:t>
            </a:r>
            <a:r>
              <a:rPr lang="en-US" altLang="ja-JP" sz="1800" dirty="0">
                <a:latin typeface="Calibri" panose="020F0502020204030204" pitchFamily="34" charset="0"/>
                <a:cs typeface="Calibri" panose="020F0502020204030204" pitchFamily="34" charset="0"/>
              </a:rPr>
              <a:t>Pearson’s chi-square  test. Metastasis-positive cases had a significantly higher </a:t>
            </a:r>
            <a:r>
              <a:rPr lang="en-US" altLang="ja-JP" sz="1800" dirty="0" err="1">
                <a:latin typeface="Calibri" panose="020F0502020204030204" pitchFamily="34" charset="0"/>
                <a:cs typeface="Calibri" panose="020F0502020204030204" pitchFamily="34" charset="0"/>
              </a:rPr>
              <a:t>ctDNA</a:t>
            </a:r>
            <a:r>
              <a:rPr lang="en-US" altLang="ja-JP" sz="1800" dirty="0">
                <a:latin typeface="Calibri" panose="020F0502020204030204" pitchFamily="34" charset="0"/>
                <a:cs typeface="Calibri" panose="020F0502020204030204" pitchFamily="34" charset="0"/>
              </a:rPr>
              <a:t> positivity rate than metastasis-negative cases.</a:t>
            </a:r>
            <a:endParaRPr lang="ja-JP" altLang="en-US" sz="1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69B0319-140B-77FE-D3F3-ED39CABD10AC}"/>
              </a:ext>
            </a:extLst>
          </p:cNvPr>
          <p:cNvSpPr txBox="1"/>
          <p:nvPr/>
        </p:nvSpPr>
        <p:spPr>
          <a:xfrm>
            <a:off x="6462486" y="2057400"/>
            <a:ext cx="20199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Pearson’s χ</a:t>
            </a:r>
            <a:r>
              <a:rPr lang="en-US" altLang="ja-JP" sz="16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 test</a:t>
            </a:r>
            <a:endParaRPr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p=0.4214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15466C3-D7B7-FD53-3F30-03554B16C733}"/>
              </a:ext>
            </a:extLst>
          </p:cNvPr>
          <p:cNvSpPr txBox="1"/>
          <p:nvPr/>
        </p:nvSpPr>
        <p:spPr>
          <a:xfrm>
            <a:off x="4792133" y="4746067"/>
            <a:ext cx="10329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N=54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32918BA-6B38-2AFC-C577-055E7EBD1C63}"/>
              </a:ext>
            </a:extLst>
          </p:cNvPr>
          <p:cNvSpPr txBox="1"/>
          <p:nvPr/>
        </p:nvSpPr>
        <p:spPr>
          <a:xfrm>
            <a:off x="7103530" y="4746067"/>
            <a:ext cx="10329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N=86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18610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04</TotalTime>
  <Words>522</Words>
  <Application>Microsoft Office PowerPoint</Application>
  <PresentationFormat>Widescreen</PresentationFormat>
  <Paragraphs>72</Paragraphs>
  <Slides>9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游ゴシック</vt:lpstr>
      <vt:lpstr>游ゴシック Light</vt:lpstr>
      <vt:lpstr>Arial</vt:lpstr>
      <vt:lpstr>Calibri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FCR_LBx07</dc:creator>
  <cp:lastModifiedBy>MDPI-76</cp:lastModifiedBy>
  <cp:revision>199</cp:revision>
  <dcterms:created xsi:type="dcterms:W3CDTF">2022-03-30T07:53:55Z</dcterms:created>
  <dcterms:modified xsi:type="dcterms:W3CDTF">2022-09-28T08:52:53Z</dcterms:modified>
</cp:coreProperties>
</file>